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>
        <p:scale>
          <a:sx n="66" d="100"/>
          <a:sy n="66" d="100"/>
        </p:scale>
        <p:origin x="1278" y="4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5643318-9817-220E-1E12-EAEB2A82FA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67471691-438C-B3DC-A4DE-A186FCF626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F038E08-C919-A7FC-76AC-6D9B631A4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73492D7-78FC-AD9B-9AE6-79EA8D380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38EED554-15CE-8C5A-2DC4-FDA099E766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108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267AAAE-AA6F-C8E1-C925-EFC01C6D17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D1F48B2B-82B1-A816-5C66-0D07C5099A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8815C8F-646D-97E7-0D73-FF7A0843C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E91A92F-379F-FA69-78BF-BFF0B5510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57850E0-BC66-75CA-9C80-5AD8EE5E6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408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1058A872-E8D3-5CE1-1F95-79855919D6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C04CB10B-78A1-BA91-34CD-A371980011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ED1D960A-35A7-199A-ED08-862A05554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2A817EE-934F-EAC0-3024-DAAA5DA03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DEA7CEA-058A-3CF8-6D41-66F19EA82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156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C937EDC-D339-3FE7-29C4-D2B7CD2EF7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E9A260AF-1FFD-7597-D1FC-54939D9EEB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5927101-C58D-56E5-D79E-61AD248DA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39EE85C7-3A19-B9D4-32C8-564C9A903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5579674-C3B8-DC96-D1E4-5CDC13839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986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A3E59CC-8308-E4BC-7772-8B550695F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A4EF7599-9A01-160D-4F62-A344A62953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EAF743D0-3C88-1EDB-69B0-89B29FECF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56432CB5-AC23-17DB-3A7F-1490F8FC1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9918F74-001E-329A-B283-56C57F9E2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686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CB270EF-4A95-CBF6-0573-A758C054E6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B0D379E5-BEED-B983-32C2-A0CBECC1BE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3ABB8E1E-52F6-2D82-8E72-E14640C53C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17D66909-314F-91F4-4A27-35C0B69E6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F9E8F488-0D4E-0263-25C9-20257DBCD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74739918-CF0C-148D-0129-7558A2FDD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883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95203E2-531B-57E1-B876-F62A19C59F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BB589B2-4CDA-2781-CD6C-B1A93BE236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545A017D-6653-1414-DEE5-B73BCEA6C0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CCC6B6ED-6B9D-E1CA-84DE-E8A41566DF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861DC27F-40DA-820F-0300-34E25F1429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68DC2CDA-0EAF-53AC-082D-079D31132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3D4DF364-6794-B7F4-F148-42EFD348C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EC878B99-D921-3D42-0344-42AAEFDE0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951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8C12E35-DF87-2EC9-CC5D-85B21A2299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729F0FF4-A7B7-5A91-2053-46724DDAC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1E315A67-2AD1-4999-F400-B409505FD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3CD472A5-B332-669D-4C3B-E1D0CCC7D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018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AA034E66-E784-CF10-5F5F-E18C3C852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58802EA4-C375-85F8-96D8-C5DF6BDE1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C654AD91-5A76-AA39-31FF-4DED8BA48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511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F0ECAB-C146-E9B2-54E8-8DBE083088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936BF3A1-C53D-D73F-4322-327576DC0D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994370F0-754E-F515-B944-8FD2068C3B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16CFA75E-F898-BE68-61E8-CC3FDCB07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E50546B3-5024-2059-AF0C-538888BC2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613C171E-0D4B-6DCD-F8E2-AAF47FB55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660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BBC19C2-3198-9788-9F9B-90B9DDF403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25B07AA5-F63D-B755-94A8-65ECAD39A8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486208E9-C200-805B-1AAE-ACBB187A04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2101A4AD-33FE-1A2A-C920-E9023BF18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EB756B7B-833B-DFB6-C23B-5F7E8DEA1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1CE8CFF8-082F-03DF-999D-118BC8DDF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934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59721697-9B01-2DA0-019E-3AF2FA9896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FFB595AC-1039-88FC-F0AA-6E9B970904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B3E69B0-C2FF-9F09-4EF5-611F7A5A40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9BA48-0035-4F3A-8581-AEE8181E7313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6A5B984-FE4C-7397-96D0-4AC54FA1AA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EF79CBB-5DE3-B43D-2672-4F06A8C617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5E538-F6CB-4B78-A5C0-C30454FED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309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4" name="図 14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5691" y="5116228"/>
            <a:ext cx="1514286" cy="1342857"/>
          </a:xfrm>
          <a:prstGeom prst="rect">
            <a:avLst/>
          </a:prstGeom>
        </p:spPr>
      </p:pic>
      <p:pic>
        <p:nvPicPr>
          <p:cNvPr id="143" name="図 14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2047" y="3554589"/>
            <a:ext cx="1521428" cy="1314286"/>
          </a:xfrm>
          <a:prstGeom prst="rect">
            <a:avLst/>
          </a:prstGeom>
        </p:spPr>
      </p:pic>
      <p:pic>
        <p:nvPicPr>
          <p:cNvPr id="142" name="図 14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30356" y="3554589"/>
            <a:ext cx="1521428" cy="1314286"/>
          </a:xfrm>
          <a:prstGeom prst="rect">
            <a:avLst/>
          </a:prstGeom>
        </p:spPr>
      </p:pic>
      <p:pic>
        <p:nvPicPr>
          <p:cNvPr id="141" name="図 14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52121" y="3555711"/>
            <a:ext cx="1521428" cy="1314286"/>
          </a:xfrm>
          <a:prstGeom prst="rect">
            <a:avLst/>
          </a:prstGeom>
        </p:spPr>
      </p:pic>
      <p:pic>
        <p:nvPicPr>
          <p:cNvPr id="139" name="図 13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41032" y="1988125"/>
            <a:ext cx="1521428" cy="1314286"/>
          </a:xfrm>
          <a:prstGeom prst="rect">
            <a:avLst/>
          </a:prstGeom>
        </p:spPr>
      </p:pic>
      <p:pic>
        <p:nvPicPr>
          <p:cNvPr id="140" name="図 13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83366" y="1996087"/>
            <a:ext cx="1521428" cy="1314286"/>
          </a:xfrm>
          <a:prstGeom prst="rect">
            <a:avLst/>
          </a:prstGeom>
        </p:spPr>
      </p:pic>
      <p:pic>
        <p:nvPicPr>
          <p:cNvPr id="138" name="図 13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52121" y="1996088"/>
            <a:ext cx="1521428" cy="1314286"/>
          </a:xfrm>
          <a:prstGeom prst="rect">
            <a:avLst/>
          </a:prstGeom>
        </p:spPr>
      </p:pic>
      <p:pic>
        <p:nvPicPr>
          <p:cNvPr id="136" name="図 13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34792" y="407819"/>
            <a:ext cx="1514286" cy="1342857"/>
          </a:xfrm>
          <a:prstGeom prst="rect">
            <a:avLst/>
          </a:prstGeom>
        </p:spPr>
      </p:pic>
      <p:pic>
        <p:nvPicPr>
          <p:cNvPr id="137" name="図 13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984773" y="417683"/>
            <a:ext cx="1514286" cy="1342857"/>
          </a:xfrm>
          <a:prstGeom prst="rect">
            <a:avLst/>
          </a:prstGeom>
        </p:spPr>
      </p:pic>
      <p:pic>
        <p:nvPicPr>
          <p:cNvPr id="135" name="図 13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55754" y="418249"/>
            <a:ext cx="1514286" cy="1342857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>
            <a:off x="3745922" y="164061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217007" y="164061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709864" y="164061"/>
            <a:ext cx="26161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3282607" y="788909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 rot="16200000">
            <a:off x="4801845" y="788909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6332801" y="788909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736303" y="1716631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236243" y="1716631"/>
            <a:ext cx="26161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729100" y="1716631"/>
            <a:ext cx="24237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3282607" y="2370054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4801845" y="2370054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6332801" y="2370054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3745922" y="3311052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217007" y="3311052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6738719" y="3311052"/>
            <a:ext cx="23275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 rot="16200000">
            <a:off x="3282607" y="3983525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 rot="16200000">
            <a:off x="4801844" y="3983525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 rot="16200000">
            <a:off x="6332801" y="3983525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774775" y="4873153"/>
            <a:ext cx="24237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 rot="16200000">
            <a:off x="3282607" y="5526576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4819360" y="1217170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76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6360318" y="1217170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788">
                <a:latin typeface="Times New Roman" panose="02020603050405020304" pitchFamily="18" charset="0"/>
                <a:cs typeface="Times New Roman" panose="02020603050405020304" pitchFamily="18" charset="0"/>
              </a:rPr>
              <a:t>= 0.67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7877697" y="1217170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74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テキスト ボックス 161"/>
          <p:cNvSpPr txBox="1"/>
          <p:nvPr/>
        </p:nvSpPr>
        <p:spPr>
          <a:xfrm>
            <a:off x="4831807" y="2799323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82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6386746" y="2799323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11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7906782" y="2799323"/>
            <a:ext cx="57579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50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4903004" y="4371268"/>
            <a:ext cx="57579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32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6364397" y="4352481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19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テキスト ボックス 166"/>
          <p:cNvSpPr txBox="1"/>
          <p:nvPr/>
        </p:nvSpPr>
        <p:spPr>
          <a:xfrm>
            <a:off x="7857010" y="4349772"/>
            <a:ext cx="57579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20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4913345" y="5921652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80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5184548" y="4141371"/>
            <a:ext cx="23596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8241418" y="4034991"/>
            <a:ext cx="23596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1" name="グループ化 330"/>
          <p:cNvGrpSpPr/>
          <p:nvPr/>
        </p:nvGrpSpPr>
        <p:grpSpPr>
          <a:xfrm>
            <a:off x="4131165" y="1455322"/>
            <a:ext cx="4468224" cy="345393"/>
            <a:chOff x="809220" y="1940428"/>
            <a:chExt cx="5957632" cy="460523"/>
          </a:xfrm>
        </p:grpSpPr>
        <p:grpSp>
          <p:nvGrpSpPr>
            <p:cNvPr id="332" name="グループ化 331"/>
            <p:cNvGrpSpPr/>
            <p:nvPr/>
          </p:nvGrpSpPr>
          <p:grpSpPr>
            <a:xfrm>
              <a:off x="809220" y="1940428"/>
              <a:ext cx="1926142" cy="460523"/>
              <a:chOff x="821920" y="2018706"/>
              <a:chExt cx="1926142" cy="460523"/>
            </a:xfrm>
          </p:grpSpPr>
          <p:sp>
            <p:nvSpPr>
              <p:cNvPr id="504" name="テキスト ボックス 503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5" name="テキスト ボックス 504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6" name="テキスト ボックス 505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7" name="テキスト ボックス 506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8" name="テキスト ボックス 507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9" name="テキスト ボックス 508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0" name="テキスト ボックス 509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1" name="テキスト ボックス 510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2" name="テキスト ボックス 511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13" name="直線コネクタ 512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4" name="直線コネクタ 513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5" name="直線コネクタ 514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6" name="正方形/長方形 515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333" name="グループ化 332"/>
            <p:cNvGrpSpPr/>
            <p:nvPr/>
          </p:nvGrpSpPr>
          <p:grpSpPr>
            <a:xfrm>
              <a:off x="2813087" y="1940428"/>
              <a:ext cx="1926142" cy="460523"/>
              <a:chOff x="821920" y="2018706"/>
              <a:chExt cx="1926142" cy="460523"/>
            </a:xfrm>
          </p:grpSpPr>
          <p:sp>
            <p:nvSpPr>
              <p:cNvPr id="491" name="テキスト ボックス 490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2" name="テキスト ボックス 491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3" name="テキスト ボックス 492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4" name="テキスト ボックス 493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5" name="テキスト ボックス 494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6" name="テキスト ボックス 495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7" name="テキスト ボックス 496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8" name="テキスト ボックス 497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9" name="テキスト ボックス 498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00" name="直線コネクタ 499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1" name="直線コネクタ 500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2" name="直線コネクタ 501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3" name="正方形/長方形 502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334" name="グループ化 333"/>
            <p:cNvGrpSpPr/>
            <p:nvPr/>
          </p:nvGrpSpPr>
          <p:grpSpPr>
            <a:xfrm>
              <a:off x="4840710" y="1940428"/>
              <a:ext cx="1926142" cy="460523"/>
              <a:chOff x="821920" y="2018706"/>
              <a:chExt cx="1926142" cy="460523"/>
            </a:xfrm>
          </p:grpSpPr>
          <p:sp>
            <p:nvSpPr>
              <p:cNvPr id="335" name="テキスト ボックス 334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6" name="テキスト ボックス 335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7" name="テキスト ボックス 336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8" name="テキスト ボックス 337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9" name="テキスト ボックス 338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0" name="テキスト ボックス 339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1" name="テキスト ボックス 340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2" name="テキスト ボックス 341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3" name="テキスト ボックス 342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87" name="直線コネクタ 486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8" name="直線コネクタ 487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9" name="直線コネクタ 488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0" name="正方形/長方形 489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</p:grpSp>
      <p:grpSp>
        <p:nvGrpSpPr>
          <p:cNvPr id="517" name="グループ化 516"/>
          <p:cNvGrpSpPr/>
          <p:nvPr/>
        </p:nvGrpSpPr>
        <p:grpSpPr>
          <a:xfrm>
            <a:off x="4145056" y="2992226"/>
            <a:ext cx="4468224" cy="345393"/>
            <a:chOff x="809220" y="1940428"/>
            <a:chExt cx="5957632" cy="460523"/>
          </a:xfrm>
        </p:grpSpPr>
        <p:grpSp>
          <p:nvGrpSpPr>
            <p:cNvPr id="518" name="グループ化 517"/>
            <p:cNvGrpSpPr/>
            <p:nvPr/>
          </p:nvGrpSpPr>
          <p:grpSpPr>
            <a:xfrm>
              <a:off x="809220" y="1940428"/>
              <a:ext cx="1926142" cy="460523"/>
              <a:chOff x="821920" y="2018706"/>
              <a:chExt cx="1926142" cy="460523"/>
            </a:xfrm>
          </p:grpSpPr>
          <p:sp>
            <p:nvSpPr>
              <p:cNvPr id="547" name="テキスト ボックス 546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8" name="テキスト ボックス 547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9" name="テキスト ボックス 548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0" name="テキスト ボックス 549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1" name="テキスト ボックス 550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2" name="テキスト ボックス 551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3" name="テキスト ボックス 552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4" name="テキスト ボックス 553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5" name="テキスト ボックス 554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56" name="直線コネクタ 555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7" name="直線コネクタ 556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8" name="直線コネクタ 557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9" name="正方形/長方形 558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519" name="グループ化 518"/>
            <p:cNvGrpSpPr/>
            <p:nvPr/>
          </p:nvGrpSpPr>
          <p:grpSpPr>
            <a:xfrm>
              <a:off x="2813087" y="1940428"/>
              <a:ext cx="1926142" cy="460523"/>
              <a:chOff x="821920" y="2018706"/>
              <a:chExt cx="1926142" cy="460523"/>
            </a:xfrm>
          </p:grpSpPr>
          <p:sp>
            <p:nvSpPr>
              <p:cNvPr id="534" name="テキスト ボックス 533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5" name="テキスト ボックス 534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6" name="テキスト ボックス 535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7" name="テキスト ボックス 536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8" name="テキスト ボックス 537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9" name="テキスト ボックス 538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0" name="テキスト ボックス 539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1" name="テキスト ボックス 540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2" name="テキスト ボックス 541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43" name="直線コネクタ 542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4" name="直線コネクタ 543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5" name="直線コネクタ 544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6" name="正方形/長方形 545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520" name="グループ化 519"/>
            <p:cNvGrpSpPr/>
            <p:nvPr/>
          </p:nvGrpSpPr>
          <p:grpSpPr>
            <a:xfrm>
              <a:off x="4840710" y="1940428"/>
              <a:ext cx="1926142" cy="460523"/>
              <a:chOff x="821920" y="2018706"/>
              <a:chExt cx="1926142" cy="460523"/>
            </a:xfrm>
          </p:grpSpPr>
          <p:sp>
            <p:nvSpPr>
              <p:cNvPr id="521" name="テキスト ボックス 520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2" name="テキスト ボックス 521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3" name="テキスト ボックス 522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4" name="テキスト ボックス 523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5" name="テキスト ボックス 524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6" name="テキスト ボックス 525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7" name="テキスト ボックス 526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8" name="テキスト ボックス 527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9" name="テキスト ボックス 528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30" name="直線コネクタ 529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1" name="直線コネクタ 530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2" name="直線コネクタ 531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3" name="正方形/長方形 532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</p:grpSp>
      <p:grpSp>
        <p:nvGrpSpPr>
          <p:cNvPr id="560" name="グループ化 559"/>
          <p:cNvGrpSpPr/>
          <p:nvPr/>
        </p:nvGrpSpPr>
        <p:grpSpPr>
          <a:xfrm>
            <a:off x="4145056" y="4563818"/>
            <a:ext cx="4468224" cy="345393"/>
            <a:chOff x="809220" y="1940428"/>
            <a:chExt cx="5957632" cy="460523"/>
          </a:xfrm>
        </p:grpSpPr>
        <p:grpSp>
          <p:nvGrpSpPr>
            <p:cNvPr id="561" name="グループ化 560"/>
            <p:cNvGrpSpPr/>
            <p:nvPr/>
          </p:nvGrpSpPr>
          <p:grpSpPr>
            <a:xfrm>
              <a:off x="809220" y="1940428"/>
              <a:ext cx="1926142" cy="460523"/>
              <a:chOff x="821920" y="2018706"/>
              <a:chExt cx="1926142" cy="460523"/>
            </a:xfrm>
          </p:grpSpPr>
          <p:sp>
            <p:nvSpPr>
              <p:cNvPr id="590" name="テキスト ボックス 589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1" name="テキスト ボックス 590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2" name="テキスト ボックス 591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3" name="テキスト ボックス 592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4" name="テキスト ボックス 593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5" name="テキスト ボックス 594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6" name="テキスト ボックス 595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7" name="テキスト ボックス 596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8" name="テキスト ボックス 597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99" name="直線コネクタ 598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0" name="直線コネクタ 599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1" name="直線コネクタ 600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2" name="正方形/長方形 601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562" name="グループ化 561"/>
            <p:cNvGrpSpPr/>
            <p:nvPr/>
          </p:nvGrpSpPr>
          <p:grpSpPr>
            <a:xfrm>
              <a:off x="2813087" y="1940428"/>
              <a:ext cx="1926142" cy="460523"/>
              <a:chOff x="821920" y="2018706"/>
              <a:chExt cx="1926142" cy="460523"/>
            </a:xfrm>
          </p:grpSpPr>
          <p:sp>
            <p:nvSpPr>
              <p:cNvPr id="577" name="テキスト ボックス 576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8" name="テキスト ボックス 577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9" name="テキスト ボックス 578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0" name="テキスト ボックス 579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1" name="テキスト ボックス 580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2" name="テキスト ボックス 581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3" name="テキスト ボックス 582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4" name="テキスト ボックス 583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5" name="テキスト ボックス 584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86" name="直線コネクタ 585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7" name="直線コネクタ 586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8" name="直線コネクタ 587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9" name="正方形/長方形 588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563" name="グループ化 562"/>
            <p:cNvGrpSpPr/>
            <p:nvPr/>
          </p:nvGrpSpPr>
          <p:grpSpPr>
            <a:xfrm>
              <a:off x="4840710" y="1940428"/>
              <a:ext cx="1926142" cy="460523"/>
              <a:chOff x="821920" y="2018706"/>
              <a:chExt cx="1926142" cy="460523"/>
            </a:xfrm>
          </p:grpSpPr>
          <p:sp>
            <p:nvSpPr>
              <p:cNvPr id="564" name="テキスト ボックス 563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5" name="テキスト ボックス 564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6" name="テキスト ボックス 565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7" name="テキスト ボックス 566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8" name="テキスト ボックス 567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9" name="テキスト ボックス 568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0" name="テキスト ボックス 569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1" name="テキスト ボックス 570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2" name="テキスト ボックス 571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73" name="直線コネクタ 572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4" name="直線コネクタ 573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5" name="直線コネクタ 574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6" name="正方形/長方形 575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</p:grpSp>
      <p:grpSp>
        <p:nvGrpSpPr>
          <p:cNvPr id="603" name="グループ化 602"/>
          <p:cNvGrpSpPr/>
          <p:nvPr/>
        </p:nvGrpSpPr>
        <p:grpSpPr>
          <a:xfrm>
            <a:off x="4142863" y="6162438"/>
            <a:ext cx="1444607" cy="345393"/>
            <a:chOff x="821920" y="2018706"/>
            <a:chExt cx="1926141" cy="460523"/>
          </a:xfrm>
        </p:grpSpPr>
        <p:sp>
          <p:nvSpPr>
            <p:cNvPr id="604" name="テキスト ボックス 603"/>
            <p:cNvSpPr txBox="1"/>
            <p:nvPr/>
          </p:nvSpPr>
          <p:spPr>
            <a:xfrm>
              <a:off x="821920" y="2019205"/>
              <a:ext cx="310343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5" name="テキスト ボックス 604"/>
            <p:cNvSpPr txBox="1"/>
            <p:nvPr/>
          </p:nvSpPr>
          <p:spPr>
            <a:xfrm>
              <a:off x="1001265" y="2018706"/>
              <a:ext cx="49889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6" name="テキスト ボックス 605"/>
            <p:cNvSpPr txBox="1"/>
            <p:nvPr/>
          </p:nvSpPr>
          <p:spPr>
            <a:xfrm>
              <a:off x="1410214" y="2019205"/>
              <a:ext cx="310342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7" name="テキスト ボックス 606"/>
            <p:cNvSpPr txBox="1"/>
            <p:nvPr/>
          </p:nvSpPr>
          <p:spPr>
            <a:xfrm>
              <a:off x="1589560" y="2018706"/>
              <a:ext cx="49889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8" name="テキスト ボックス 607"/>
            <p:cNvSpPr txBox="1"/>
            <p:nvPr/>
          </p:nvSpPr>
          <p:spPr>
            <a:xfrm>
              <a:off x="1969693" y="2019205"/>
              <a:ext cx="310342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9" name="テキスト ボックス 608"/>
            <p:cNvSpPr txBox="1"/>
            <p:nvPr/>
          </p:nvSpPr>
          <p:spPr>
            <a:xfrm>
              <a:off x="2123638" y="2018706"/>
              <a:ext cx="49889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0" name="テキスト ボックス 609"/>
            <p:cNvSpPr txBox="1"/>
            <p:nvPr/>
          </p:nvSpPr>
          <p:spPr>
            <a:xfrm>
              <a:off x="1018764" y="2202231"/>
              <a:ext cx="524074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-D1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" name="テキスト ボックス 610"/>
            <p:cNvSpPr txBox="1"/>
            <p:nvPr/>
          </p:nvSpPr>
          <p:spPr>
            <a:xfrm>
              <a:off x="1575560" y="2202231"/>
              <a:ext cx="524074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-D2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" name="テキスト ボックス 611"/>
            <p:cNvSpPr txBox="1"/>
            <p:nvPr/>
          </p:nvSpPr>
          <p:spPr>
            <a:xfrm>
              <a:off x="2043126" y="2194538"/>
              <a:ext cx="524074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-D3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13" name="直線コネクタ 612"/>
            <p:cNvCxnSpPr/>
            <p:nvPr/>
          </p:nvCxnSpPr>
          <p:spPr>
            <a:xfrm>
              <a:off x="1031671" y="2244201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4" name="直線コネクタ 613"/>
            <p:cNvCxnSpPr/>
            <p:nvPr/>
          </p:nvCxnSpPr>
          <p:spPr>
            <a:xfrm>
              <a:off x="1579027" y="2244201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5" name="直線コネクタ 614"/>
            <p:cNvCxnSpPr/>
            <p:nvPr/>
          </p:nvCxnSpPr>
          <p:spPr>
            <a:xfrm>
              <a:off x="2142265" y="2244201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6" name="正方形/長方形 615"/>
            <p:cNvSpPr/>
            <p:nvPr/>
          </p:nvSpPr>
          <p:spPr>
            <a:xfrm>
              <a:off x="2352227" y="2023050"/>
              <a:ext cx="395834" cy="2769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[h]</a:t>
              </a:r>
              <a:endParaRPr lang="ja-JP" altLang="en-US" sz="750" dirty="0"/>
            </a:p>
          </p:txBody>
        </p:sp>
      </p:grpSp>
      <p:sp>
        <p:nvSpPr>
          <p:cNvPr id="2" name="テキスト ボックス 1"/>
          <p:cNvSpPr txBox="1"/>
          <p:nvPr/>
        </p:nvSpPr>
        <p:spPr>
          <a:xfrm>
            <a:off x="5716841" y="5063240"/>
            <a:ext cx="589143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-dependent changes in premenstrual symptom scores: “swelling of the face” (a), “swelling of the arms and hands” (b), “breast tenderness/ soreness” (c), “abdominal bloating” (d), “swelling of the legs” (e), “heavy legs” (f), “fatigue” (g), “not feeling well/ feeling sick” (h), “irritability/ anger”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“appetite/ food craving” (j). The data are expressed as the mean ± SEM. The data were analyzed using a general linear mixed model for repeated measures, with adjustment for carryover effects, and the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 is shown in each panel. *represents a significant between-supplement difference. Open circles (○) and closed circles (●) represent placebo and </a:t>
            </a:r>
            <a:r>
              <a:rPr lang="el-GR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c intake, respectively. 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3498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396</Words>
  <Application>Microsoft Office PowerPoint</Application>
  <PresentationFormat>ワイド画面</PresentationFormat>
  <Paragraphs>13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Higuchi, Tomoko(樋口　智子)</cp:lastModifiedBy>
  <cp:revision>2</cp:revision>
  <dcterms:created xsi:type="dcterms:W3CDTF">2022-07-11T13:38:26Z</dcterms:created>
  <dcterms:modified xsi:type="dcterms:W3CDTF">2023-01-05T09:59:49Z</dcterms:modified>
</cp:coreProperties>
</file>